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  <p:sldId id="264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6" autoAdjust="0"/>
    <p:restoredTop sz="94660"/>
  </p:normalViewPr>
  <p:slideViewPr>
    <p:cSldViewPr snapToGrid="0">
      <p:cViewPr varScale="1">
        <p:scale>
          <a:sx n="87" d="100"/>
          <a:sy n="87" d="100"/>
        </p:scale>
        <p:origin x="523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image" Target="../media/image13.emf"/><Relationship Id="rId1" Type="http://schemas.openxmlformats.org/officeDocument/2006/relationships/image" Target="../media/image12.emf"/><Relationship Id="rId4" Type="http://schemas.openxmlformats.org/officeDocument/2006/relationships/image" Target="../media/image15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B61EE2-98E3-4343-BA83-867CCB455CB0}" type="datetimeFigureOut">
              <a:rPr lang="en-US" smtClean="0"/>
              <a:t>11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1B939-919F-4F62-AC00-7B9DEFE060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71453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B61EE2-98E3-4343-BA83-867CCB455CB0}" type="datetimeFigureOut">
              <a:rPr lang="en-US" smtClean="0"/>
              <a:t>11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1B939-919F-4F62-AC00-7B9DEFE060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13075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B61EE2-98E3-4343-BA83-867CCB455CB0}" type="datetimeFigureOut">
              <a:rPr lang="en-US" smtClean="0"/>
              <a:t>11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1B939-919F-4F62-AC00-7B9DEFE060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71081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B61EE2-98E3-4343-BA83-867CCB455CB0}" type="datetimeFigureOut">
              <a:rPr lang="en-US" smtClean="0"/>
              <a:t>11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1B939-919F-4F62-AC00-7B9DEFE060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92836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B61EE2-98E3-4343-BA83-867CCB455CB0}" type="datetimeFigureOut">
              <a:rPr lang="en-US" smtClean="0"/>
              <a:t>11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1B939-919F-4F62-AC00-7B9DEFE060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40019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B61EE2-98E3-4343-BA83-867CCB455CB0}" type="datetimeFigureOut">
              <a:rPr lang="en-US" smtClean="0"/>
              <a:t>11/1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1B939-919F-4F62-AC00-7B9DEFE060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75381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B61EE2-98E3-4343-BA83-867CCB455CB0}" type="datetimeFigureOut">
              <a:rPr lang="en-US" smtClean="0"/>
              <a:t>11/19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1B939-919F-4F62-AC00-7B9DEFE060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21760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B61EE2-98E3-4343-BA83-867CCB455CB0}" type="datetimeFigureOut">
              <a:rPr lang="en-US" smtClean="0"/>
              <a:t>11/19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1B939-919F-4F62-AC00-7B9DEFE060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73459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B61EE2-98E3-4343-BA83-867CCB455CB0}" type="datetimeFigureOut">
              <a:rPr lang="en-US" smtClean="0"/>
              <a:t>11/19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1B939-919F-4F62-AC00-7B9DEFE060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61697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B61EE2-98E3-4343-BA83-867CCB455CB0}" type="datetimeFigureOut">
              <a:rPr lang="en-US" smtClean="0"/>
              <a:t>11/1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1B939-919F-4F62-AC00-7B9DEFE060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76400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B61EE2-98E3-4343-BA83-867CCB455CB0}" type="datetimeFigureOut">
              <a:rPr lang="en-US" smtClean="0"/>
              <a:t>11/1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1B939-919F-4F62-AC00-7B9DEFE060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51400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B61EE2-98E3-4343-BA83-867CCB455CB0}" type="datetimeFigureOut">
              <a:rPr lang="en-US" smtClean="0"/>
              <a:t>11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21B939-919F-4F62-AC00-7B9DEFE060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9805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3" Type="http://schemas.microsoft.com/office/2007/relationships/hdphoto" Target="../media/hdphoto1.wdp"/><Relationship Id="rId7" Type="http://schemas.openxmlformats.org/officeDocument/2006/relationships/image" Target="../media/image7.png"/><Relationship Id="rId12" Type="http://schemas.openxmlformats.org/officeDocument/2006/relationships/image" Target="../media/image11.tiff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tiff"/><Relationship Id="rId11" Type="http://schemas.openxmlformats.org/officeDocument/2006/relationships/image" Target="../media/image10.tiff"/><Relationship Id="rId5" Type="http://schemas.openxmlformats.org/officeDocument/2006/relationships/image" Target="../media/image5.tiff"/><Relationship Id="rId10" Type="http://schemas.openxmlformats.org/officeDocument/2006/relationships/image" Target="../media/image9.tiff"/><Relationship Id="rId4" Type="http://schemas.openxmlformats.org/officeDocument/2006/relationships/image" Target="../media/image4.tiff"/><Relationship Id="rId9" Type="http://schemas.openxmlformats.org/officeDocument/2006/relationships/image" Target="../media/image8.tiff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3.e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15.emf"/><Relationship Id="rId4" Type="http://schemas.openxmlformats.org/officeDocument/2006/relationships/image" Target="../media/image12.emf"/><Relationship Id="rId9" Type="http://schemas.openxmlformats.org/officeDocument/2006/relationships/oleObject" Target="../embeddings/oleObject4.bin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png"/><Relationship Id="rId13" Type="http://schemas.microsoft.com/office/2007/relationships/hdphoto" Target="../media/hdphoto8.wdp"/><Relationship Id="rId3" Type="http://schemas.microsoft.com/office/2007/relationships/hdphoto" Target="../media/hdphoto3.wdp"/><Relationship Id="rId7" Type="http://schemas.microsoft.com/office/2007/relationships/hdphoto" Target="../media/hdphoto5.wdp"/><Relationship Id="rId12" Type="http://schemas.openxmlformats.org/officeDocument/2006/relationships/image" Target="../media/image21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8.png"/><Relationship Id="rId11" Type="http://schemas.microsoft.com/office/2007/relationships/hdphoto" Target="../media/hdphoto7.wdp"/><Relationship Id="rId5" Type="http://schemas.microsoft.com/office/2007/relationships/hdphoto" Target="../media/hdphoto4.wdp"/><Relationship Id="rId10" Type="http://schemas.openxmlformats.org/officeDocument/2006/relationships/image" Target="../media/image20.png"/><Relationship Id="rId4" Type="http://schemas.openxmlformats.org/officeDocument/2006/relationships/image" Target="../media/image17.png"/><Relationship Id="rId9" Type="http://schemas.microsoft.com/office/2007/relationships/hdphoto" Target="../media/hdphoto6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76A30DC5-8717-18A6-1BF4-5567F02A0E6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49296" y="0"/>
            <a:ext cx="9436970" cy="667657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134196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0" y="1375848"/>
            <a:ext cx="11982994" cy="267765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ure 1. Shifts in protein expression across different genotypes of </a:t>
            </a:r>
            <a:r>
              <a:rPr lang="en-US" sz="1600" b="1" i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itrus </a:t>
            </a:r>
            <a:r>
              <a:rPr lang="en-US" sz="1600" b="1" i="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nensis</a:t>
            </a:r>
            <a:r>
              <a:rPr lang="en-US" sz="1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 in response to healthy </a:t>
            </a:r>
            <a:r>
              <a:rPr lang="en-US" sz="1600" b="1" i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. </a:t>
            </a:r>
            <a:r>
              <a:rPr lang="en-US" sz="1600" b="1" i="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itri</a:t>
            </a:r>
            <a:r>
              <a:rPr lang="en-US" sz="1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 and </a:t>
            </a:r>
            <a:r>
              <a:rPr lang="en-US" sz="1600" b="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Las</a:t>
            </a:r>
            <a:r>
              <a:rPr lang="en-US" sz="1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infection </a:t>
            </a:r>
            <a:r>
              <a:rPr lang="en-US" sz="1600" b="1" i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. </a:t>
            </a:r>
            <a:r>
              <a:rPr lang="en-US" sz="1600" b="1" i="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itri</a:t>
            </a:r>
            <a:r>
              <a:rPr lang="en-US" sz="1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 at 1 dpi, 6 dpi, and 30 dpi. </a:t>
            </a:r>
            <a:r>
              <a:rPr lang="en-US" sz="1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 figure compares protein expression changes in infected treatments relative to the control (non-infected). Full circles indicate proteins with significant differences at 1 dpi, while empty circles represent proteins significantly affected later (6 dpi or 30 dpi). Green arrows denote shifts in protein expression (regression coefficients) observed at 6 dpi, and brown arrows indicate changes at 30 dpi.</a:t>
            </a:r>
          </a:p>
          <a:p>
            <a:pPr algn="just">
              <a:lnSpc>
                <a:spcPct val="150000"/>
              </a:lnSpc>
            </a:pPr>
            <a:r>
              <a:rPr lang="en-US" sz="1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en-US" sz="1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</a:br>
            <a:endParaRPr lang="en-US" sz="16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583076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614261" y="698867"/>
            <a:ext cx="4951187" cy="3095924"/>
            <a:chOff x="213668" y="3494317"/>
            <a:chExt cx="4163632" cy="3016150"/>
          </a:xfrm>
        </p:grpSpPr>
        <p:sp>
          <p:nvSpPr>
            <p:cNvPr id="3" name="Rectangle 2"/>
            <p:cNvSpPr/>
            <p:nvPr/>
          </p:nvSpPr>
          <p:spPr>
            <a:xfrm>
              <a:off x="3705321" y="5545712"/>
              <a:ext cx="67197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04 </a:t>
              </a:r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Rectangle 3"/>
            <p:cNvSpPr/>
            <p:nvPr/>
          </p:nvSpPr>
          <p:spPr>
            <a:xfrm>
              <a:off x="3705321" y="5068800"/>
              <a:ext cx="67197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530 </a:t>
              </a:r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" name="Group 4"/>
            <p:cNvGrpSpPr/>
            <p:nvPr/>
          </p:nvGrpSpPr>
          <p:grpSpPr>
            <a:xfrm>
              <a:off x="213668" y="3494317"/>
              <a:ext cx="3586302" cy="3016150"/>
              <a:chOff x="213668" y="3494317"/>
              <a:chExt cx="3586302" cy="3016150"/>
            </a:xfrm>
          </p:grpSpPr>
          <p:grpSp>
            <p:nvGrpSpPr>
              <p:cNvPr id="6" name="Group 5"/>
              <p:cNvGrpSpPr/>
              <p:nvPr/>
            </p:nvGrpSpPr>
            <p:grpSpPr>
              <a:xfrm>
                <a:off x="213668" y="3494317"/>
                <a:ext cx="3586302" cy="3016150"/>
                <a:chOff x="9862814" y="4068236"/>
                <a:chExt cx="1932103" cy="2243704"/>
              </a:xfrm>
            </p:grpSpPr>
            <p:sp>
              <p:nvSpPr>
                <p:cNvPr id="8" name="TextBox 7"/>
                <p:cNvSpPr txBox="1"/>
                <p:nvPr/>
              </p:nvSpPr>
              <p:spPr>
                <a:xfrm>
                  <a:off x="10310011" y="6111191"/>
                  <a:ext cx="674960" cy="20074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LIBASIA_05320</a:t>
                  </a:r>
                </a:p>
              </p:txBody>
            </p:sp>
            <p:pic>
              <p:nvPicPr>
                <p:cNvPr id="9" name="Picture 2" descr="Image preview"/>
                <p:cNvPicPr>
                  <a:picLocks noChangeAspect="1" noChangeArrowheads="1"/>
                </p:cNvPicPr>
                <p:nvPr/>
              </p:nvPicPr>
              <p:blipFill rotWithShape="1"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2925" r="48241" b="3981"/>
                <a:stretch/>
              </p:blipFill>
              <p:spPr bwMode="auto">
                <a:xfrm>
                  <a:off x="10164020" y="4493810"/>
                  <a:ext cx="1598411" cy="1646268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10" name="TextBox 9"/>
                <p:cNvSpPr txBox="1"/>
                <p:nvPr/>
              </p:nvSpPr>
              <p:spPr>
                <a:xfrm rot="18404735">
                  <a:off x="10142678" y="4216787"/>
                  <a:ext cx="462916" cy="16581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ead</a:t>
                  </a:r>
                </a:p>
              </p:txBody>
            </p:sp>
            <p:sp>
              <p:nvSpPr>
                <p:cNvPr id="11" name="TextBox 10"/>
                <p:cNvSpPr txBox="1"/>
                <p:nvPr/>
              </p:nvSpPr>
              <p:spPr>
                <a:xfrm rot="18631248">
                  <a:off x="10764526" y="4258649"/>
                  <a:ext cx="470071" cy="16581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ody</a:t>
                  </a:r>
                </a:p>
              </p:txBody>
            </p:sp>
            <p:sp>
              <p:nvSpPr>
                <p:cNvPr id="12" name="TextBox 11"/>
                <p:cNvSpPr txBox="1"/>
                <p:nvPr/>
              </p:nvSpPr>
              <p:spPr>
                <a:xfrm rot="18665155">
                  <a:off x="11130503" y="4275938"/>
                  <a:ext cx="462917" cy="16581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ead</a:t>
                  </a:r>
                </a:p>
              </p:txBody>
            </p:sp>
            <p:sp>
              <p:nvSpPr>
                <p:cNvPr id="13" name="TextBox 12"/>
                <p:cNvSpPr txBox="1"/>
                <p:nvPr/>
              </p:nvSpPr>
              <p:spPr>
                <a:xfrm rot="18665155">
                  <a:off x="11402782" y="4250429"/>
                  <a:ext cx="470071" cy="16581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ody</a:t>
                  </a:r>
                </a:p>
              </p:txBody>
            </p:sp>
            <p:sp>
              <p:nvSpPr>
                <p:cNvPr id="14" name="TextBox 13"/>
                <p:cNvSpPr txBox="1"/>
                <p:nvPr/>
              </p:nvSpPr>
              <p:spPr>
                <a:xfrm>
                  <a:off x="11150382" y="6111191"/>
                  <a:ext cx="644535" cy="20074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LIBASIA_04560</a:t>
                  </a:r>
                </a:p>
              </p:txBody>
            </p:sp>
            <p:sp>
              <p:nvSpPr>
                <p:cNvPr id="15" name="Rectangle 14"/>
                <p:cNvSpPr/>
                <p:nvPr/>
              </p:nvSpPr>
              <p:spPr>
                <a:xfrm>
                  <a:off x="9862814" y="4919234"/>
                  <a:ext cx="369798" cy="188887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05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500 </a:t>
                  </a:r>
                  <a:r>
                    <a:rPr lang="en-US" sz="105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bp</a:t>
                  </a:r>
                  <a:endParaRPr lang="en-US" sz="105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" name="Rectangle 15"/>
                <p:cNvSpPr/>
                <p:nvPr/>
              </p:nvSpPr>
              <p:spPr>
                <a:xfrm>
                  <a:off x="9935480" y="5585162"/>
                  <a:ext cx="288619" cy="188887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05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5 </a:t>
                  </a:r>
                  <a:r>
                    <a:rPr lang="en-US" sz="105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bp</a:t>
                  </a:r>
                  <a:endParaRPr lang="en-US" sz="105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" name="Rectangle 16"/>
                <p:cNvSpPr/>
                <p:nvPr/>
              </p:nvSpPr>
              <p:spPr>
                <a:xfrm>
                  <a:off x="9895224" y="5434100"/>
                  <a:ext cx="329208" cy="188887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05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0 </a:t>
                  </a:r>
                  <a:r>
                    <a:rPr lang="en-US" sz="105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bp</a:t>
                  </a:r>
                  <a:endParaRPr lang="en-US" sz="105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" name="Rectangle 17"/>
                <p:cNvSpPr/>
                <p:nvPr/>
              </p:nvSpPr>
              <p:spPr>
                <a:xfrm>
                  <a:off x="9899254" y="5202268"/>
                  <a:ext cx="329208" cy="188887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05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0 </a:t>
                  </a:r>
                  <a:r>
                    <a:rPr lang="en-US" sz="105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bp</a:t>
                  </a:r>
                  <a:endParaRPr lang="en-US" sz="105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cxnSp>
            <p:nvCxnSpPr>
              <p:cNvPr id="7" name="Straight Connector 6"/>
              <p:cNvCxnSpPr/>
              <p:nvPr/>
            </p:nvCxnSpPr>
            <p:spPr>
              <a:xfrm flipH="1">
                <a:off x="2508614" y="4113707"/>
                <a:ext cx="17930" cy="2090496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20" name="Rectangle 19"/>
          <p:cNvSpPr/>
          <p:nvPr/>
        </p:nvSpPr>
        <p:spPr>
          <a:xfrm>
            <a:off x="133302" y="4292264"/>
            <a:ext cx="11833029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2. 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T-PCR amplification of CLIBASIA_05320 and CLIBASIA_04560 mRNA from </a:t>
            </a:r>
            <a:r>
              <a:rPr lang="en-US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Las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infected body and heads of psyllids.  </a:t>
            </a:r>
          </a:p>
        </p:txBody>
      </p:sp>
    </p:spTree>
    <p:extLst>
      <p:ext uri="{BB962C8B-B14F-4D97-AF65-F5344CB8AC3E}">
        <p14:creationId xmlns:p14="http://schemas.microsoft.com/office/powerpoint/2010/main" val="216377709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741747" y="191706"/>
            <a:ext cx="8255692" cy="6461642"/>
            <a:chOff x="586542" y="838676"/>
            <a:chExt cx="6592136" cy="5743062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C7302E81-3450-2647-9409-CDC29E0607F6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1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892944" y="4807802"/>
              <a:ext cx="2057400" cy="1773936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DA92E2FE-F0C4-CD4C-AEB7-532343B7184C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000426" y="4807802"/>
              <a:ext cx="2057400" cy="1773936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3BBBD01D-6E41-C14F-B2C8-E0BF8DF204A1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121278" y="4807802"/>
              <a:ext cx="2057400" cy="1773936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24D4DB3A-C7B8-8D4D-B2E3-BFB9397CBC16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121278" y="2971174"/>
              <a:ext cx="2057400" cy="1773936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207BCC88-C249-BD48-956D-A9B878AEBE58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15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892944" y="2971174"/>
              <a:ext cx="2057400" cy="1773936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AF2DFB0A-5379-0D41-87AD-804E3C5D569C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3000426" y="2971174"/>
              <a:ext cx="2057400" cy="1773936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A84FEC9B-EF30-BB4A-97E7-57A03C53E96B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5121278" y="1134546"/>
              <a:ext cx="2057400" cy="1773936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D628B5E5-2BBA-394B-B0A1-43C96F464BFA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3000426" y="1134546"/>
              <a:ext cx="2057400" cy="1773936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EEF48E51-13BF-3B45-89D8-93E85659230F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892944" y="1134546"/>
              <a:ext cx="2057400" cy="1773936"/>
            </a:xfrm>
            <a:prstGeom prst="rect">
              <a:avLst/>
            </a:prstGeom>
          </p:spPr>
        </p:pic>
        <p:sp>
          <p:nvSpPr>
            <p:cNvPr id="12" name="TextBox 11"/>
            <p:cNvSpPr txBox="1"/>
            <p:nvPr/>
          </p:nvSpPr>
          <p:spPr>
            <a:xfrm rot="16200000">
              <a:off x="330693" y="1964512"/>
              <a:ext cx="782032" cy="2703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PCBD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 rot="16200000">
              <a:off x="294692" y="3737175"/>
              <a:ext cx="904115" cy="2703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risilkin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 rot="16200000">
              <a:off x="101243" y="5559604"/>
              <a:ext cx="1291013" cy="2703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"/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CG31997-PA</a:t>
              </a:r>
              <a:endParaRPr lang="en-US" sz="1600" b="1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1627950" y="838676"/>
              <a:ext cx="526333" cy="3282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GFP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3419518" y="838676"/>
              <a:ext cx="1335287" cy="3282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NLS:mCherry</a:t>
              </a:r>
              <a:endParaRPr 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5859715" y="844153"/>
              <a:ext cx="690171" cy="3282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Merge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32452975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348342" y="578681"/>
            <a:ext cx="9675223" cy="157414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3. 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tracellular localization of ACP effectors </a:t>
            </a:r>
            <a:r>
              <a:rPr lang="en-US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 planta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The </a:t>
            </a:r>
            <a:r>
              <a:rPr lang="en-US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GFP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fused PCBD, </a:t>
            </a:r>
            <a:r>
              <a:rPr lang="en-US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risilkin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CG31997-PA together with </a:t>
            </a:r>
            <a:r>
              <a:rPr lang="en-US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Cherry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agged NLS were transiently expressed in epidermal layer of </a:t>
            </a:r>
            <a:r>
              <a:rPr lang="en-US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. </a:t>
            </a:r>
            <a:r>
              <a:rPr lang="en-US" i="1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enthamiana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The images were acquired after 48 </a:t>
            </a:r>
            <a:r>
              <a:rPr lang="en-US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pi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with GFP and </a:t>
            </a:r>
            <a:r>
              <a:rPr lang="en-US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Cherry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hannels using a confocal microscope (Leica SP8). The experiments were performed three time with similar results. Scale bar, </a:t>
            </a:r>
            <a:r>
              <a:rPr lang="en-US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50.19 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µm</a:t>
            </a:r>
          </a:p>
        </p:txBody>
      </p:sp>
    </p:spTree>
    <p:extLst>
      <p:ext uri="{BB962C8B-B14F-4D97-AF65-F5344CB8AC3E}">
        <p14:creationId xmlns:p14="http://schemas.microsoft.com/office/powerpoint/2010/main" val="374802891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/>
          <p:cNvSpPr txBox="1"/>
          <p:nvPr/>
        </p:nvSpPr>
        <p:spPr>
          <a:xfrm flipH="1">
            <a:off x="622124" y="368173"/>
            <a:ext cx="3164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8" name="TextBox 17"/>
          <p:cNvSpPr txBox="1"/>
          <p:nvPr/>
        </p:nvSpPr>
        <p:spPr>
          <a:xfrm flipH="1">
            <a:off x="6187308" y="261257"/>
            <a:ext cx="3164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9" name="TextBox 18"/>
          <p:cNvSpPr txBox="1"/>
          <p:nvPr/>
        </p:nvSpPr>
        <p:spPr>
          <a:xfrm flipH="1">
            <a:off x="804536" y="3413735"/>
            <a:ext cx="3164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0" name="TextBox 19"/>
          <p:cNvSpPr txBox="1"/>
          <p:nvPr/>
        </p:nvSpPr>
        <p:spPr>
          <a:xfrm flipH="1">
            <a:off x="6210782" y="3413735"/>
            <a:ext cx="3164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pSp>
        <p:nvGrpSpPr>
          <p:cNvPr id="12" name="Group 11"/>
          <p:cNvGrpSpPr/>
          <p:nvPr/>
        </p:nvGrpSpPr>
        <p:grpSpPr>
          <a:xfrm>
            <a:off x="973152" y="457616"/>
            <a:ext cx="3557782" cy="2861802"/>
            <a:chOff x="960878" y="296636"/>
            <a:chExt cx="3884619" cy="3290638"/>
          </a:xfrm>
        </p:grpSpPr>
        <p:grpSp>
          <p:nvGrpSpPr>
            <p:cNvPr id="16" name="Group 15"/>
            <p:cNvGrpSpPr/>
            <p:nvPr/>
          </p:nvGrpSpPr>
          <p:grpSpPr>
            <a:xfrm>
              <a:off x="960878" y="296636"/>
              <a:ext cx="3884619" cy="3290638"/>
              <a:chOff x="247294" y="744819"/>
              <a:chExt cx="2633066" cy="2155135"/>
            </a:xfrm>
          </p:grpSpPr>
          <p:graphicFrame>
            <p:nvGraphicFramePr>
              <p:cNvPr id="3" name="Object 2"/>
              <p:cNvGraphicFramePr>
                <a:graphicFrameLocks noChangeAspect="1"/>
              </p:cNvGraphicFramePr>
              <p:nvPr/>
            </p:nvGraphicFramePr>
            <p:xfrm>
              <a:off x="337094" y="744819"/>
              <a:ext cx="2543266" cy="215513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26" name="Prism 8" r:id="rId3" imgW="3328137" imgH="2599643" progId="Prism8.Document">
                      <p:embed/>
                    </p:oleObj>
                  </mc:Choice>
                  <mc:Fallback>
                    <p:oleObj name="Prism 8" r:id="rId3" imgW="3328137" imgH="2599643" progId="Prism8.Document">
                      <p:embed/>
                      <p:pic>
                        <p:nvPicPr>
                          <p:cNvPr id="3" name="Object 2"/>
                          <p:cNvPicPr/>
                          <p:nvPr/>
                        </p:nvPicPr>
                        <p:blipFill>
                          <a:blip r:embed="rId4"/>
                          <a:stretch>
                            <a:fillRect/>
                          </a:stretch>
                        </p:blipFill>
                        <p:spPr>
                          <a:xfrm>
                            <a:off x="337094" y="744819"/>
                            <a:ext cx="2543266" cy="215513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7" name="TextBox 6"/>
              <p:cNvSpPr txBox="1"/>
              <p:nvPr/>
            </p:nvSpPr>
            <p:spPr>
              <a:xfrm rot="16200000">
                <a:off x="-187602" y="1634802"/>
                <a:ext cx="1078410" cy="20861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ene Expression</a:t>
                </a:r>
              </a:p>
            </p:txBody>
          </p:sp>
        </p:grpSp>
        <p:sp>
          <p:nvSpPr>
            <p:cNvPr id="2" name="TextBox 1"/>
            <p:cNvSpPr txBox="1"/>
            <p:nvPr/>
          </p:nvSpPr>
          <p:spPr>
            <a:xfrm>
              <a:off x="3364122" y="591231"/>
              <a:ext cx="30489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26" name="Group 25"/>
          <p:cNvGrpSpPr/>
          <p:nvPr/>
        </p:nvGrpSpPr>
        <p:grpSpPr>
          <a:xfrm>
            <a:off x="6624745" y="592955"/>
            <a:ext cx="3492579" cy="2591123"/>
            <a:chOff x="6557838" y="573564"/>
            <a:chExt cx="3438678" cy="2905285"/>
          </a:xfrm>
        </p:grpSpPr>
        <p:grpSp>
          <p:nvGrpSpPr>
            <p:cNvPr id="6" name="Group 5"/>
            <p:cNvGrpSpPr/>
            <p:nvPr/>
          </p:nvGrpSpPr>
          <p:grpSpPr>
            <a:xfrm>
              <a:off x="6557838" y="573564"/>
              <a:ext cx="3438678" cy="2905285"/>
              <a:chOff x="3917853" y="692492"/>
              <a:chExt cx="2514344" cy="2184497"/>
            </a:xfrm>
          </p:grpSpPr>
          <p:graphicFrame>
            <p:nvGraphicFramePr>
              <p:cNvPr id="4" name="Object 3"/>
              <p:cNvGraphicFramePr>
                <a:graphicFrameLocks noChangeAspect="1"/>
              </p:cNvGraphicFramePr>
              <p:nvPr/>
            </p:nvGraphicFramePr>
            <p:xfrm>
              <a:off x="4004129" y="692492"/>
              <a:ext cx="2428068" cy="218449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27" name="Prism 8" r:id="rId5" imgW="3528992" imgH="3175581" progId="Prism8.Document">
                      <p:embed/>
                    </p:oleObj>
                  </mc:Choice>
                  <mc:Fallback>
                    <p:oleObj name="Prism 8" r:id="rId5" imgW="3528992" imgH="3175581" progId="Prism8.Document">
                      <p:embed/>
                      <p:pic>
                        <p:nvPicPr>
                          <p:cNvPr id="4" name="Object 3"/>
                          <p:cNvPicPr/>
                          <p:nvPr/>
                        </p:nvPicPr>
                        <p:blipFill>
                          <a:blip r:embed="rId6"/>
                          <a:stretch>
                            <a:fillRect/>
                          </a:stretch>
                        </p:blipFill>
                        <p:spPr>
                          <a:xfrm>
                            <a:off x="4004129" y="692492"/>
                            <a:ext cx="2428068" cy="218449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9" name="TextBox 8"/>
              <p:cNvSpPr txBox="1"/>
              <p:nvPr/>
            </p:nvSpPr>
            <p:spPr>
              <a:xfrm rot="16200000">
                <a:off x="3446052" y="1584037"/>
                <a:ext cx="1140362" cy="19676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ene Expression</a:t>
                </a:r>
              </a:p>
            </p:txBody>
          </p:sp>
        </p:grpSp>
        <p:sp>
          <p:nvSpPr>
            <p:cNvPr id="22" name="TextBox 21"/>
            <p:cNvSpPr txBox="1"/>
            <p:nvPr/>
          </p:nvSpPr>
          <p:spPr>
            <a:xfrm>
              <a:off x="8709139" y="587839"/>
              <a:ext cx="30489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25" name="Group 24"/>
          <p:cNvGrpSpPr/>
          <p:nvPr/>
        </p:nvGrpSpPr>
        <p:grpSpPr>
          <a:xfrm>
            <a:off x="6650135" y="3715510"/>
            <a:ext cx="3467189" cy="2700671"/>
            <a:chOff x="6637938" y="3884138"/>
            <a:chExt cx="3358585" cy="2887533"/>
          </a:xfrm>
        </p:grpSpPr>
        <p:grpSp>
          <p:nvGrpSpPr>
            <p:cNvPr id="15" name="Group 14"/>
            <p:cNvGrpSpPr/>
            <p:nvPr/>
          </p:nvGrpSpPr>
          <p:grpSpPr>
            <a:xfrm>
              <a:off x="6637938" y="3884138"/>
              <a:ext cx="3358585" cy="2887533"/>
              <a:chOff x="3889967" y="3690256"/>
              <a:chExt cx="2641462" cy="2306725"/>
            </a:xfrm>
          </p:grpSpPr>
          <p:graphicFrame>
            <p:nvGraphicFramePr>
              <p:cNvPr id="8" name="Object 7"/>
              <p:cNvGraphicFramePr>
                <a:graphicFrameLocks noChangeAspect="1"/>
              </p:cNvGraphicFramePr>
              <p:nvPr/>
            </p:nvGraphicFramePr>
            <p:xfrm>
              <a:off x="4004129" y="3690256"/>
              <a:ext cx="2527300" cy="230672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28" name="Prism 8" r:id="rId7" imgW="3629779" imgH="3276371" progId="Prism8.Document">
                      <p:embed/>
                    </p:oleObj>
                  </mc:Choice>
                  <mc:Fallback>
                    <p:oleObj name="Prism 8" r:id="rId7" imgW="3629779" imgH="3276371" progId="Prism8.Document">
                      <p:embed/>
                      <p:pic>
                        <p:nvPicPr>
                          <p:cNvPr id="8" name="Object 7"/>
                          <p:cNvPicPr/>
                          <p:nvPr/>
                        </p:nvPicPr>
                        <p:blipFill>
                          <a:blip r:embed="rId8"/>
                          <a:stretch>
                            <a:fillRect/>
                          </a:stretch>
                        </p:blipFill>
                        <p:spPr>
                          <a:xfrm>
                            <a:off x="4004129" y="3690256"/>
                            <a:ext cx="2527300" cy="230672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1" name="TextBox 10"/>
              <p:cNvSpPr txBox="1"/>
              <p:nvPr/>
            </p:nvSpPr>
            <p:spPr>
              <a:xfrm rot="16200000">
                <a:off x="3385776" y="4633917"/>
                <a:ext cx="1223131" cy="2147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ene Expression</a:t>
                </a:r>
              </a:p>
            </p:txBody>
          </p:sp>
        </p:grpSp>
        <p:sp>
          <p:nvSpPr>
            <p:cNvPr id="23" name="TextBox 22"/>
            <p:cNvSpPr txBox="1"/>
            <p:nvPr/>
          </p:nvSpPr>
          <p:spPr>
            <a:xfrm>
              <a:off x="8736289" y="4232534"/>
              <a:ext cx="30489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13" name="Group 12"/>
          <p:cNvGrpSpPr/>
          <p:nvPr/>
        </p:nvGrpSpPr>
        <p:grpSpPr>
          <a:xfrm>
            <a:off x="1002461" y="3877384"/>
            <a:ext cx="3528473" cy="2725305"/>
            <a:chOff x="933016" y="3761062"/>
            <a:chExt cx="3852618" cy="3133688"/>
          </a:xfrm>
        </p:grpSpPr>
        <p:grpSp>
          <p:nvGrpSpPr>
            <p:cNvPr id="14" name="Group 13"/>
            <p:cNvGrpSpPr/>
            <p:nvPr/>
          </p:nvGrpSpPr>
          <p:grpSpPr>
            <a:xfrm>
              <a:off x="933016" y="3761062"/>
              <a:ext cx="3852618" cy="3133688"/>
              <a:chOff x="296343" y="3690256"/>
              <a:chExt cx="2670718" cy="2306725"/>
            </a:xfrm>
          </p:grpSpPr>
          <p:graphicFrame>
            <p:nvGraphicFramePr>
              <p:cNvPr id="5" name="Object 4"/>
              <p:cNvGraphicFramePr>
                <a:graphicFrameLocks noChangeAspect="1"/>
              </p:cNvGraphicFramePr>
              <p:nvPr/>
            </p:nvGraphicFramePr>
            <p:xfrm>
              <a:off x="413364" y="3690256"/>
              <a:ext cx="2553697" cy="230672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29" name="Prism 8" r:id="rId9" imgW="3282423" imgH="2965364" progId="Prism8.Document">
                      <p:embed/>
                    </p:oleObj>
                  </mc:Choice>
                  <mc:Fallback>
                    <p:oleObj name="Prism 8" r:id="rId9" imgW="3282423" imgH="2965364" progId="Prism8.Document">
                      <p:embed/>
                      <p:pic>
                        <p:nvPicPr>
                          <p:cNvPr id="5" name="Object 4"/>
                          <p:cNvPicPr/>
                          <p:nvPr/>
                        </p:nvPicPr>
                        <p:blipFill>
                          <a:blip r:embed="rId10"/>
                          <a:stretch>
                            <a:fillRect/>
                          </a:stretch>
                        </p:blipFill>
                        <p:spPr>
                          <a:xfrm>
                            <a:off x="413364" y="3690256"/>
                            <a:ext cx="2553697" cy="230672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0" name="TextBox 9"/>
              <p:cNvSpPr txBox="1"/>
              <p:nvPr/>
            </p:nvSpPr>
            <p:spPr>
              <a:xfrm rot="16200000">
                <a:off x="-203016" y="4589503"/>
                <a:ext cx="1212075" cy="21335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ene Expression</a:t>
                </a:r>
              </a:p>
            </p:txBody>
          </p:sp>
        </p:grpSp>
        <p:sp>
          <p:nvSpPr>
            <p:cNvPr id="24" name="TextBox 23"/>
            <p:cNvSpPr txBox="1"/>
            <p:nvPr/>
          </p:nvSpPr>
          <p:spPr>
            <a:xfrm>
              <a:off x="3351097" y="3838459"/>
              <a:ext cx="30489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85915351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435428" y="744224"/>
            <a:ext cx="11625943" cy="258532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Figure 4. 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xpression of psyllid effectors in </a:t>
            </a:r>
            <a:r>
              <a:rPr lang="en-US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. </a:t>
            </a:r>
            <a:r>
              <a:rPr lang="en-US" i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enthamiana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Quantitative polymerase chain reaction of  </a:t>
            </a:r>
            <a:r>
              <a:rPr lang="en-US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erritin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A)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</a:t>
            </a:r>
            <a:r>
              <a:rPr lang="en-US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G31997-PA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B)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</a:t>
            </a:r>
            <a:r>
              <a:rPr lang="en-US" i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risilkin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C) 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d </a:t>
            </a:r>
            <a:r>
              <a:rPr lang="en-US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CBD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D). The GFP tagged effector proteins along with control were expressed in </a:t>
            </a:r>
            <a:r>
              <a:rPr lang="en-US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. </a:t>
            </a:r>
            <a:r>
              <a:rPr lang="en-US" i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enthamiana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 The results are represented as mean ±SD; leaves (n=3) from different plants were used. </a:t>
            </a:r>
            <a:r>
              <a:rPr lang="en-US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sterik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ndicate statistical significance (p &lt; 0.05).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tatistical significance was calculated using student’s </a:t>
            </a:r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test. 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mages are acquired from </a:t>
            </a:r>
            <a:r>
              <a:rPr lang="en-US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raphPad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Prism 8. The experiments were repeated three times with similar results. </a:t>
            </a:r>
          </a:p>
        </p:txBody>
      </p:sp>
    </p:spTree>
    <p:extLst>
      <p:ext uri="{BB962C8B-B14F-4D97-AF65-F5344CB8AC3E}">
        <p14:creationId xmlns:p14="http://schemas.microsoft.com/office/powerpoint/2010/main" val="355683496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242899" y="343498"/>
            <a:ext cx="7979478" cy="4350423"/>
            <a:chOff x="1222870" y="855903"/>
            <a:chExt cx="6777359" cy="3524175"/>
          </a:xfrm>
        </p:grpSpPr>
        <p:grpSp>
          <p:nvGrpSpPr>
            <p:cNvPr id="3" name="Group 2"/>
            <p:cNvGrpSpPr/>
            <p:nvPr/>
          </p:nvGrpSpPr>
          <p:grpSpPr>
            <a:xfrm>
              <a:off x="1482266" y="1108913"/>
              <a:ext cx="6517117" cy="1593778"/>
              <a:chOff x="761076" y="2360695"/>
              <a:chExt cx="7276500" cy="1755648"/>
            </a:xfrm>
          </p:grpSpPr>
          <p:pic>
            <p:nvPicPr>
              <p:cNvPr id="12" name="Picture 11">
                <a:extLst>
                  <a:ext uri="{FF2B5EF4-FFF2-40B4-BE49-F238E27FC236}">
                    <a16:creationId xmlns:a16="http://schemas.microsoft.com/office/drawing/2014/main" id="{A1FBE73D-E8F9-FA4C-97C6-6C4A730D18B8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26000" contrast="-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761076" y="2360695"/>
                <a:ext cx="2395728" cy="1755648"/>
              </a:xfrm>
              <a:prstGeom prst="rect">
                <a:avLst/>
              </a:prstGeom>
            </p:spPr>
          </p:pic>
          <p:pic>
            <p:nvPicPr>
              <p:cNvPr id="13" name="Picture 12">
                <a:extLst>
                  <a:ext uri="{FF2B5EF4-FFF2-40B4-BE49-F238E27FC236}">
                    <a16:creationId xmlns:a16="http://schemas.microsoft.com/office/drawing/2014/main" id="{5B94CACD-CA1E-C044-858E-BCB0DBB2CE27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20000" contrast="-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3201462" y="2360695"/>
                <a:ext cx="2395728" cy="1755648"/>
              </a:xfrm>
              <a:prstGeom prst="rect">
                <a:avLst/>
              </a:prstGeom>
            </p:spPr>
          </p:pic>
          <p:pic>
            <p:nvPicPr>
              <p:cNvPr id="14" name="Picture 13">
                <a:extLst>
                  <a:ext uri="{FF2B5EF4-FFF2-40B4-BE49-F238E27FC236}">
                    <a16:creationId xmlns:a16="http://schemas.microsoft.com/office/drawing/2014/main" id="{4359FA1E-F31B-8B49-9D6F-4B2D1EDB787A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6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bright="12000" contrast="-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5641848" y="2360695"/>
                <a:ext cx="2395728" cy="1755648"/>
              </a:xfrm>
              <a:prstGeom prst="rect">
                <a:avLst/>
              </a:prstGeom>
            </p:spPr>
          </p:pic>
          <p:cxnSp>
            <p:nvCxnSpPr>
              <p:cNvPr id="15" name="Straight Connector 14"/>
              <p:cNvCxnSpPr/>
              <p:nvPr/>
            </p:nvCxnSpPr>
            <p:spPr>
              <a:xfrm>
                <a:off x="7504176" y="4069080"/>
                <a:ext cx="483108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Straight Connector 15"/>
              <p:cNvCxnSpPr/>
              <p:nvPr/>
            </p:nvCxnSpPr>
            <p:spPr>
              <a:xfrm>
                <a:off x="5035296" y="4069080"/>
                <a:ext cx="483108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Straight Connector 16"/>
              <p:cNvCxnSpPr/>
              <p:nvPr/>
            </p:nvCxnSpPr>
            <p:spPr>
              <a:xfrm>
                <a:off x="2619756" y="4061460"/>
                <a:ext cx="483108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" name="TextBox 3"/>
            <p:cNvSpPr txBox="1"/>
            <p:nvPr/>
          </p:nvSpPr>
          <p:spPr>
            <a:xfrm>
              <a:off x="2315129" y="884123"/>
              <a:ext cx="514923" cy="2742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GFP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4185156" y="855903"/>
              <a:ext cx="1278728" cy="2742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NLS:mCherry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6620031" y="855903"/>
              <a:ext cx="670135" cy="2742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Merge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AC78A82E-1B8A-8642-836D-74E95B715D82}"/>
                </a:ext>
              </a:extLst>
            </p:cNvPr>
            <p:cNvSpPr txBox="1"/>
            <p:nvPr/>
          </p:nvSpPr>
          <p:spPr>
            <a:xfrm rot="16200000">
              <a:off x="693952" y="1799378"/>
              <a:ext cx="1319592" cy="2614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LIBASIA_05320</a:t>
              </a:r>
            </a:p>
          </p:txBody>
        </p:sp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ACF0907C-194C-B248-9D38-8ABE6325B0B8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19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5853675" y="2789022"/>
              <a:ext cx="2146554" cy="1591056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BC905A3F-DA30-CD43-A08A-29D6AE6D70FB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15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3667548" y="2789022"/>
              <a:ext cx="2146554" cy="1591056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77E901C0-8055-4F42-8522-04B6617362EE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2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16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476974" y="2789022"/>
              <a:ext cx="2146554" cy="1591056"/>
            </a:xfrm>
            <a:prstGeom prst="rect">
              <a:avLst/>
            </a:prstGeom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AC78A82E-1B8A-8642-836D-74E95B715D82}"/>
                </a:ext>
              </a:extLst>
            </p:cNvPr>
            <p:cNvSpPr txBox="1"/>
            <p:nvPr/>
          </p:nvSpPr>
          <p:spPr>
            <a:xfrm rot="16200000">
              <a:off x="693779" y="3476208"/>
              <a:ext cx="1319592" cy="2614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LIBASIA_04560</a:t>
              </a:r>
            </a:p>
          </p:txBody>
        </p:sp>
      </p:grpSp>
      <p:sp>
        <p:nvSpPr>
          <p:cNvPr id="18" name="Rectangle 17"/>
          <p:cNvSpPr/>
          <p:nvPr/>
        </p:nvSpPr>
        <p:spPr>
          <a:xfrm>
            <a:off x="558249" y="5274599"/>
            <a:ext cx="10519053" cy="114621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6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5. </a:t>
            </a:r>
            <a:r>
              <a:rPr lang="en-US" sz="16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bcellular localization of </a:t>
            </a:r>
            <a:r>
              <a:rPr lang="en-US" sz="16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Las</a:t>
            </a:r>
            <a:r>
              <a:rPr lang="en-US" sz="16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effectors </a:t>
            </a:r>
            <a:r>
              <a:rPr lang="en-US" sz="16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 planta</a:t>
            </a:r>
            <a:r>
              <a:rPr lang="en-US" sz="16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The </a:t>
            </a:r>
            <a:r>
              <a:rPr lang="en-US" sz="16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GFP</a:t>
            </a:r>
            <a:r>
              <a:rPr lang="en-US" sz="16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fused CLIBASIA_05320 and CLIBASIA_04560, together with </a:t>
            </a:r>
            <a:r>
              <a:rPr lang="en-US" sz="16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Cherry</a:t>
            </a:r>
            <a:r>
              <a:rPr lang="en-US" sz="16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agged NLS, were transiently expressed in the epidermal layer of </a:t>
            </a:r>
            <a:r>
              <a:rPr lang="en-US" sz="16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. </a:t>
            </a:r>
            <a:r>
              <a:rPr lang="en-US" sz="1600" i="1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enthamiana</a:t>
            </a:r>
            <a:r>
              <a:rPr lang="en-US" sz="16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The </a:t>
            </a:r>
            <a:r>
              <a:rPr lang="en-US" sz="16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magse</a:t>
            </a:r>
            <a:r>
              <a:rPr lang="en-US" sz="16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were acquired after 48 </a:t>
            </a:r>
            <a:r>
              <a:rPr lang="en-US" sz="16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pi</a:t>
            </a:r>
            <a:r>
              <a:rPr lang="en-US" sz="16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with GFP and </a:t>
            </a:r>
            <a:r>
              <a:rPr lang="en-US" sz="16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Cherry</a:t>
            </a:r>
            <a:r>
              <a:rPr lang="en-US" sz="16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hannels, using a confocal microscope (Leica SP8). Scale bar, </a:t>
            </a:r>
            <a:r>
              <a:rPr lang="en-US" sz="1600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50.19 </a:t>
            </a:r>
            <a:r>
              <a:rPr lang="en-US" sz="16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µm. The experiments were performed three times with similar results.</a:t>
            </a:r>
          </a:p>
        </p:txBody>
      </p:sp>
    </p:spTree>
    <p:extLst>
      <p:ext uri="{BB962C8B-B14F-4D97-AF65-F5344CB8AC3E}">
        <p14:creationId xmlns:p14="http://schemas.microsoft.com/office/powerpoint/2010/main" val="42614473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326</Words>
  <Application>Microsoft Office PowerPoint</Application>
  <PresentationFormat>Widescreen</PresentationFormat>
  <Paragraphs>41</Paragraphs>
  <Slides>8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4" baseType="lpstr">
      <vt:lpstr>Arial</vt:lpstr>
      <vt:lpstr>Calibri</vt:lpstr>
      <vt:lpstr>Calibri Light</vt:lpstr>
      <vt:lpstr>Times New Roman</vt:lpstr>
      <vt:lpstr>Office Theme</vt:lpstr>
      <vt:lpstr>Prism 8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mina</dc:creator>
  <cp:lastModifiedBy>Sarmina</cp:lastModifiedBy>
  <cp:revision>5</cp:revision>
  <dcterms:created xsi:type="dcterms:W3CDTF">2025-06-29T21:21:22Z</dcterms:created>
  <dcterms:modified xsi:type="dcterms:W3CDTF">2025-11-19T10:38:24Z</dcterms:modified>
</cp:coreProperties>
</file>